
<file path=[Content_Types].xml><?xml version="1.0" encoding="utf-8"?>
<Types xmlns="http://schemas.openxmlformats.org/package/2006/content-types">
  <Default Extension="bin" ContentType="application/vnd.openxmlformats-officedocument.oleObject"/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7" r:id="rId2"/>
    <p:sldId id="268" r:id="rId3"/>
    <p:sldId id="269" r:id="rId4"/>
    <p:sldId id="270" r:id="rId5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224" autoAdjust="0"/>
  </p:normalViewPr>
  <p:slideViewPr>
    <p:cSldViewPr>
      <p:cViewPr varScale="1">
        <p:scale>
          <a:sx n="101" d="100"/>
          <a:sy n="101" d="100"/>
        </p:scale>
        <p:origin x="1017" y="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i.tiss\Desktop\01%20%20PROJECTS\01%20%20ADULT%20OBESITY\01%20COMMUNICATIONS\01%20%20PAPERS\15%20%20%20EPHX2\01%20%20%202020-01-09\2020-01-28_Final\Reviewed\2020-02-19_Gender%20effect_RT-PCR%20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T-PCR Gender'!$I$2</c:f>
              <c:strCache>
                <c:ptCount val="1"/>
                <c:pt idx="0">
                  <c:v>RT-PCR A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T-PCR Gender'!$M$4:$M$6</c:f>
                <c:numCache>
                  <c:formatCode>General</c:formatCode>
                  <c:ptCount val="3"/>
                  <c:pt idx="1">
                    <c:v>0.3</c:v>
                  </c:pt>
                  <c:pt idx="2">
                    <c:v>0.23</c:v>
                  </c:pt>
                </c:numCache>
              </c:numRef>
            </c:plus>
            <c:minus>
              <c:numRef>
                <c:f>'RT-PCR Gender'!$M$4:$M$6</c:f>
                <c:numCache>
                  <c:formatCode>General</c:formatCode>
                  <c:ptCount val="3"/>
                  <c:pt idx="1">
                    <c:v>0.3</c:v>
                  </c:pt>
                  <c:pt idx="2">
                    <c:v>0.2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T-PCR Gender'!$O$4:$O$6</c:f>
              <c:strCache>
                <c:ptCount val="3"/>
                <c:pt idx="0">
                  <c:v> Lean</c:v>
                </c:pt>
                <c:pt idx="1">
                  <c:v>Female obese</c:v>
                </c:pt>
                <c:pt idx="2">
                  <c:v>Male obese</c:v>
                </c:pt>
              </c:strCache>
            </c:strRef>
          </c:cat>
          <c:val>
            <c:numRef>
              <c:f>'RT-PCR Gender'!$N$4:$N$6</c:f>
              <c:numCache>
                <c:formatCode>0.00</c:formatCode>
                <c:ptCount val="3"/>
                <c:pt idx="0" formatCode="General">
                  <c:v>1</c:v>
                </c:pt>
                <c:pt idx="1">
                  <c:v>2.3604651162790695</c:v>
                </c:pt>
                <c:pt idx="2">
                  <c:v>2.8023255813953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E7-42CD-ACDA-2765CA26B0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18346799"/>
        <c:axId val="718270303"/>
      </c:barChart>
      <c:catAx>
        <c:axId val="7183467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8270303"/>
        <c:crosses val="autoZero"/>
        <c:auto val="1"/>
        <c:lblAlgn val="ctr"/>
        <c:lblOffset val="100"/>
        <c:noMultiLvlLbl val="0"/>
      </c:catAx>
      <c:valAx>
        <c:axId val="718270303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ysClr val="windowText" lastClr="000000"/>
                    </a:solidFill>
                  </a:rPr>
                  <a:t> Relative expression levels in EPHX2 mRNA</a:t>
                </a:r>
              </a:p>
            </c:rich>
          </c:tx>
          <c:layout>
            <c:manualLayout>
              <c:xMode val="edge"/>
              <c:yMode val="edge"/>
              <c:x val="1.8146166693494694E-2"/>
              <c:y val="0.169241692161003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8346799"/>
        <c:crosses val="autoZero"/>
        <c:crossBetween val="between"/>
        <c:majorUnit val="1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A25B27-41FC-4E33-82D4-63262D1AA49D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01A56-3CA7-4EA4-BCC6-4DAA5023E63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C5026-C30D-438C-A107-92D7ADDCF014}" type="datetimeFigureOut">
              <a:rPr lang="en-US" smtClean="0"/>
              <a:pPr/>
              <a:t>2020-02-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D1754-25BF-4F0E-BD3F-C6AA5628CF1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EDC914E-DF1D-4B79-844D-CF40E0EF51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3967934"/>
              </p:ext>
            </p:extLst>
          </p:nvPr>
        </p:nvGraphicFramePr>
        <p:xfrm>
          <a:off x="533400" y="1600200"/>
          <a:ext cx="5746750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Document" r:id="rId3" imgW="5759361" imgH="1794938" progId="Word.Document.12">
                  <p:embed/>
                </p:oleObj>
              </mc:Choice>
              <mc:Fallback>
                <p:oleObj name="Document" r:id="rId3" imgW="5759361" imgH="1794938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3400" y="1600200"/>
                        <a:ext cx="5746750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CE28977A-AA99-4148-B43C-6881A702E2EA}"/>
              </a:ext>
            </a:extLst>
          </p:cNvPr>
          <p:cNvSpPr/>
          <p:nvPr/>
        </p:nvSpPr>
        <p:spPr>
          <a:xfrm>
            <a:off x="533400" y="1143000"/>
            <a:ext cx="4876800" cy="2821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Yu Mincho" panose="02020400000000000000" pitchFamily="18" charset="-128"/>
              </a:rPr>
              <a:t>Table S1: Primers used for real-time PCR to analyze gene expression</a:t>
            </a:r>
            <a:endParaRPr lang="en-US" sz="1100" kern="100" dirty="0">
              <a:effectLst/>
              <a:latin typeface="Yu Mincho" panose="02020400000000000000" pitchFamily="18" charset="-128"/>
              <a:ea typeface="Yu Mincho" panose="02020400000000000000" pitchFamily="18" charset="-128"/>
              <a:cs typeface="Yu Mincho" panose="02020400000000000000" pitchFamily="18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105443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2983A6B9-C1B0-49FF-A86D-73CA0E77C3F6}"/>
              </a:ext>
            </a:extLst>
          </p:cNvPr>
          <p:cNvGrpSpPr/>
          <p:nvPr/>
        </p:nvGrpSpPr>
        <p:grpSpPr>
          <a:xfrm>
            <a:off x="2438400" y="1371600"/>
            <a:ext cx="3423037" cy="2735248"/>
            <a:chOff x="1148963" y="914400"/>
            <a:chExt cx="3423037" cy="2735248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E7895703-D29C-4680-88F6-79835090DF4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42255296"/>
                </p:ext>
              </p:extLst>
            </p:nvPr>
          </p:nvGraphicFramePr>
          <p:xfrm>
            <a:off x="1148963" y="914400"/>
            <a:ext cx="3423037" cy="27352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D9B4228A-F487-48B6-8826-68C89B07DCA8}"/>
                </a:ext>
              </a:extLst>
            </p:cNvPr>
            <p:cNvCxnSpPr/>
            <p:nvPr/>
          </p:nvCxnSpPr>
          <p:spPr bwMode="auto">
            <a:xfrm rot="10800000" flipV="1">
              <a:off x="3082326" y="1447800"/>
              <a:ext cx="914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7D30C1A-4BF8-4D58-81E3-D70EB868FAF6}"/>
                </a:ext>
              </a:extLst>
            </p:cNvPr>
            <p:cNvSpPr txBox="1"/>
            <p:nvPr/>
          </p:nvSpPr>
          <p:spPr>
            <a:xfrm>
              <a:off x="3352800" y="1140023"/>
              <a:ext cx="4491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/>
                <a:t>n.s</a:t>
              </a:r>
              <a:r>
                <a:rPr lang="en-US" sz="1400" b="1" dirty="0"/>
                <a:t>.</a:t>
              </a:r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D330AE8F-6869-4CCA-ADBD-5B603BF40B73}"/>
              </a:ext>
            </a:extLst>
          </p:cNvPr>
          <p:cNvSpPr/>
          <p:nvPr/>
        </p:nvSpPr>
        <p:spPr>
          <a:xfrm>
            <a:off x="457200" y="5410200"/>
            <a:ext cx="8077200" cy="1030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. EPHX2 mRNA expression in SAT from human subject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RNA expression levels of EPHX2 in subcutaneous adipose tissue (SAT) of female and male obese participants at baseline (n=5 each) were measured by quantitative real-time PCR. GAPDH was used as an internal control for normalization. Data are presented as fold changes compared with normal-weight participants. 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69395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1C9D72E4-E07E-46E8-8EB0-0CFDDDFB02D3}"/>
              </a:ext>
            </a:extLst>
          </p:cNvPr>
          <p:cNvGrpSpPr/>
          <p:nvPr/>
        </p:nvGrpSpPr>
        <p:grpSpPr>
          <a:xfrm>
            <a:off x="2252997" y="1524000"/>
            <a:ext cx="5001878" cy="3185049"/>
            <a:chOff x="2252997" y="1524000"/>
            <a:chExt cx="5001878" cy="3185049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DCAD890A-7681-45AD-9FA9-E687E93C6F8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1184820"/>
                </p:ext>
              </p:extLst>
            </p:nvPr>
          </p:nvGraphicFramePr>
          <p:xfrm>
            <a:off x="2514600" y="1524000"/>
            <a:ext cx="4740275" cy="3181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5" name="Prism 8" r:id="rId3" imgW="4739746" imgH="3181961" progId="Prism8.Document">
                    <p:embed/>
                  </p:oleObj>
                </mc:Choice>
                <mc:Fallback>
                  <p:oleObj name="Prism 8" r:id="rId3" imgW="4739746" imgH="3181961" progId="Prism8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E2C14718-D261-4674-A932-41E91D8D8BC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514600" y="1524000"/>
                          <a:ext cx="4740275" cy="3181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D9B4228A-F487-48B6-8826-68C89B07DCA8}"/>
                </a:ext>
              </a:extLst>
            </p:cNvPr>
            <p:cNvCxnSpPr/>
            <p:nvPr/>
          </p:nvCxnSpPr>
          <p:spPr bwMode="auto">
            <a:xfrm rot="10800000" flipV="1">
              <a:off x="3810000" y="2057400"/>
              <a:ext cx="914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1831DF-10F5-4744-9D5B-80910F7A78CD}"/>
                </a:ext>
              </a:extLst>
            </p:cNvPr>
            <p:cNvSpPr txBox="1"/>
            <p:nvPr/>
          </p:nvSpPr>
          <p:spPr>
            <a:xfrm>
              <a:off x="3581400" y="4401272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Lea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D5C53BA-7F6A-437C-A251-68F584E1BC98}"/>
                </a:ext>
              </a:extLst>
            </p:cNvPr>
            <p:cNvSpPr txBox="1"/>
            <p:nvPr/>
          </p:nvSpPr>
          <p:spPr>
            <a:xfrm>
              <a:off x="4572000" y="4401272"/>
              <a:ext cx="6543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Obes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274688E-2571-45BC-9222-646B8E5005C9}"/>
                </a:ext>
              </a:extLst>
            </p:cNvPr>
            <p:cNvSpPr txBox="1"/>
            <p:nvPr/>
          </p:nvSpPr>
          <p:spPr>
            <a:xfrm>
              <a:off x="5410200" y="4390342"/>
              <a:ext cx="1164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Obese (after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1BC75E-9C99-410E-8477-9F780BD29D81}"/>
                </a:ext>
              </a:extLst>
            </p:cNvPr>
            <p:cNvSpPr txBox="1"/>
            <p:nvPr/>
          </p:nvSpPr>
          <p:spPr>
            <a:xfrm rot="16200000">
              <a:off x="1281993" y="2853065"/>
              <a:ext cx="246522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400" b="1" dirty="0"/>
                <a:t>EPHX2 protein levels in PBMCs</a:t>
              </a:r>
            </a:p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+mn-cs"/>
                </a:defRPr>
              </a:pPr>
              <a:r>
                <a:rPr lang="en-US" sz="1400" b="1" dirty="0"/>
                <a:t>(normalized to GAPDH)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7CDF9626-CC48-4841-A46B-093EE2B931FC}"/>
                </a:ext>
              </a:extLst>
            </p:cNvPr>
            <p:cNvCxnSpPr/>
            <p:nvPr/>
          </p:nvCxnSpPr>
          <p:spPr bwMode="auto">
            <a:xfrm rot="10800000" flipV="1">
              <a:off x="4953000" y="2053701"/>
              <a:ext cx="914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81">
              <a:extLst>
                <a:ext uri="{FF2B5EF4-FFF2-40B4-BE49-F238E27FC236}">
                  <a16:creationId xmlns:a16="http://schemas.microsoft.com/office/drawing/2014/main" id="{8C24271A-E385-41BF-BC7C-2C803384F8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2179" y="1778196"/>
              <a:ext cx="31012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ym typeface="Symbol" pitchFamily="18" charset="2"/>
                </a:rPr>
                <a:t>*</a:t>
              </a:r>
              <a:endParaRPr lang="en-US" sz="1400" b="1" dirty="0"/>
            </a:p>
          </p:txBody>
        </p:sp>
        <p:sp>
          <p:nvSpPr>
            <p:cNvPr id="13" name="Rectangle 81">
              <a:extLst>
                <a:ext uri="{FF2B5EF4-FFF2-40B4-BE49-F238E27FC236}">
                  <a16:creationId xmlns:a16="http://schemas.microsoft.com/office/drawing/2014/main" id="{345A8BF5-4109-4A43-8EF2-B6BB5F0E18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9685" y="1752600"/>
              <a:ext cx="31012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ym typeface="Symbol" pitchFamily="18" charset="2"/>
                </a:rPr>
                <a:t>*</a:t>
              </a:r>
              <a:endParaRPr lang="en-US" sz="1400" b="1" dirty="0"/>
            </a:p>
          </p:txBody>
        </p: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D25C94BD-EEA9-493E-870B-217FDCEFC517}"/>
              </a:ext>
            </a:extLst>
          </p:cNvPr>
          <p:cNvSpPr/>
          <p:nvPr/>
        </p:nvSpPr>
        <p:spPr>
          <a:xfrm>
            <a:off x="582979" y="5036818"/>
            <a:ext cx="7978042" cy="8186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2. EPHX2 protein levels in PBMCs from human subject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PHX2 protein expression in PBMCs </a:t>
            </a:r>
            <a:r>
              <a:rPr lang="en-US" sz="1200" i="1" dirty="0">
                <a:latin typeface="Times New Roman" panose="02020603050405020304" pitchFamily="18" charset="0"/>
                <a:cs typeface="Arial" panose="020B0604020202020204" pitchFamily="34" charset="0"/>
              </a:rPr>
              <a:t>from lean, obese before exercise, and obese after exercise groups (at least n=9 each). Protein levels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measured by western blotting. GAPDH was used as an internal control for normalization. *p &lt; 0.05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04325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8213692-9E49-41A3-98CD-8E6D2A551444}"/>
              </a:ext>
            </a:extLst>
          </p:cNvPr>
          <p:cNvGrpSpPr/>
          <p:nvPr/>
        </p:nvGrpSpPr>
        <p:grpSpPr>
          <a:xfrm>
            <a:off x="359429" y="510727"/>
            <a:ext cx="8138154" cy="1328114"/>
            <a:chOff x="113377" y="772353"/>
            <a:chExt cx="8138154" cy="1328114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59DB89D-5C93-427D-9ABB-6E37D7E08B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377" y="1003187"/>
              <a:ext cx="1554480" cy="107887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02E80E11-88A4-47FB-B596-6E3C045F99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543"/>
            <a:stretch/>
          </p:blipFill>
          <p:spPr>
            <a:xfrm>
              <a:off x="1761200" y="1003187"/>
              <a:ext cx="1554480" cy="1086076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BF910A52-28C5-4014-B542-54052D16D0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2829"/>
            <a:stretch/>
          </p:blipFill>
          <p:spPr>
            <a:xfrm>
              <a:off x="3409023" y="1003187"/>
              <a:ext cx="1554480" cy="1078903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0E466CE8-7436-4430-9517-8AD5E56EEB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499"/>
            <a:stretch/>
          </p:blipFill>
          <p:spPr>
            <a:xfrm>
              <a:off x="5056846" y="1003187"/>
              <a:ext cx="1550671" cy="109728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269FDE33-E1B7-4EB2-A981-31FBEB10BD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371"/>
            <a:stretch/>
          </p:blipFill>
          <p:spPr>
            <a:xfrm>
              <a:off x="6700860" y="1003187"/>
              <a:ext cx="1550671" cy="109728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4584E04-8B3D-4B81-985B-4D7F8ADF00C7}"/>
                </a:ext>
              </a:extLst>
            </p:cNvPr>
            <p:cNvSpPr txBox="1"/>
            <p:nvPr/>
          </p:nvSpPr>
          <p:spPr>
            <a:xfrm>
              <a:off x="774401" y="781016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90EC3AF-E84A-4F6B-ADA9-5C3760DA8BBE}"/>
                </a:ext>
              </a:extLst>
            </p:cNvPr>
            <p:cNvSpPr txBox="1"/>
            <p:nvPr/>
          </p:nvSpPr>
          <p:spPr>
            <a:xfrm>
              <a:off x="2448691" y="781016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4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0BE482F-626F-4638-AE18-9B074CAEB35D}"/>
                </a:ext>
              </a:extLst>
            </p:cNvPr>
            <p:cNvSpPr txBox="1"/>
            <p:nvPr/>
          </p:nvSpPr>
          <p:spPr>
            <a:xfrm>
              <a:off x="4044238" y="772354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6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A55EE7C-125D-4959-901F-08DC11754CA0}"/>
                </a:ext>
              </a:extLst>
            </p:cNvPr>
            <p:cNvSpPr txBox="1"/>
            <p:nvPr/>
          </p:nvSpPr>
          <p:spPr>
            <a:xfrm>
              <a:off x="5668277" y="772353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8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A5E1E37-B355-4215-98E1-CBFC27A93C2F}"/>
                </a:ext>
              </a:extLst>
            </p:cNvPr>
            <p:cNvSpPr txBox="1"/>
            <p:nvPr/>
          </p:nvSpPr>
          <p:spPr>
            <a:xfrm>
              <a:off x="7256717" y="772353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12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7DE9DBED-D6C2-43C4-A444-BD1DF1F7B885}"/>
              </a:ext>
            </a:extLst>
          </p:cNvPr>
          <p:cNvGrpSpPr/>
          <p:nvPr/>
        </p:nvGrpSpPr>
        <p:grpSpPr>
          <a:xfrm>
            <a:off x="533400" y="2700622"/>
            <a:ext cx="2904850" cy="1906395"/>
            <a:chOff x="1116522" y="2700622"/>
            <a:chExt cx="2904850" cy="1906395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FFE63EC5-9E2C-4936-B76D-3FBF741067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12" t="41989" r="28908"/>
            <a:stretch/>
          </p:blipFill>
          <p:spPr>
            <a:xfrm>
              <a:off x="1116522" y="2905107"/>
              <a:ext cx="895157" cy="1371600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ECB6DFA4-7087-49BC-AC0C-99F53ED2DC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30" t="36988" r="28919" b="5096"/>
            <a:stretch/>
          </p:blipFill>
          <p:spPr>
            <a:xfrm>
              <a:off x="2117748" y="2901940"/>
              <a:ext cx="897893" cy="1371600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621B2802-B181-4C99-857A-BE242A12C1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06" t="29079" r="19909" b="10336"/>
            <a:stretch/>
          </p:blipFill>
          <p:spPr>
            <a:xfrm>
              <a:off x="3121710" y="2895600"/>
              <a:ext cx="899662" cy="1371600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9F07269-0D75-4CEF-AED7-BDBF3F7C834F}"/>
                </a:ext>
              </a:extLst>
            </p:cNvPr>
            <p:cNvSpPr txBox="1"/>
            <p:nvPr/>
          </p:nvSpPr>
          <p:spPr>
            <a:xfrm>
              <a:off x="1864460" y="4330018"/>
              <a:ext cx="13496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hSAT</a:t>
              </a:r>
              <a:r>
                <a:rPr lang="en-US" sz="1200" b="1" dirty="0"/>
                <a:t> primary cell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B614BF1-DBCF-442D-A08D-DCCD3EFFC198}"/>
                </a:ext>
              </a:extLst>
            </p:cNvPr>
            <p:cNvSpPr txBox="1"/>
            <p:nvPr/>
          </p:nvSpPr>
          <p:spPr>
            <a:xfrm>
              <a:off x="1412140" y="2700622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10BCC9C-CF83-49E7-BEAE-010B49408E93}"/>
                </a:ext>
              </a:extLst>
            </p:cNvPr>
            <p:cNvSpPr txBox="1"/>
            <p:nvPr/>
          </p:nvSpPr>
          <p:spPr>
            <a:xfrm>
              <a:off x="2418265" y="2700622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75D7E02-6FDA-4CB5-BA5E-AC5E7990DDB5}"/>
                </a:ext>
              </a:extLst>
            </p:cNvPr>
            <p:cNvSpPr txBox="1"/>
            <p:nvPr/>
          </p:nvSpPr>
          <p:spPr>
            <a:xfrm>
              <a:off x="3434235" y="2700622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10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9C757FBA-5A62-4720-8C42-E081E6DCA2EE}"/>
              </a:ext>
            </a:extLst>
          </p:cNvPr>
          <p:cNvGrpSpPr/>
          <p:nvPr/>
        </p:nvGrpSpPr>
        <p:grpSpPr>
          <a:xfrm>
            <a:off x="5331454" y="2678900"/>
            <a:ext cx="3140950" cy="1946409"/>
            <a:chOff x="2983306" y="4731390"/>
            <a:chExt cx="3140950" cy="1946409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DC16FA2F-08BE-43E2-A10A-11C1F1BDD8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55" t="43222" r="14286"/>
            <a:stretch/>
          </p:blipFill>
          <p:spPr>
            <a:xfrm>
              <a:off x="2983306" y="4947381"/>
              <a:ext cx="979432" cy="137160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78D6AB63-115A-4537-8A75-823D27103C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97" t="34169" r="15739" b="10517"/>
            <a:stretch/>
          </p:blipFill>
          <p:spPr>
            <a:xfrm>
              <a:off x="4067744" y="4947381"/>
              <a:ext cx="979431" cy="1371600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45D5623-5F55-4D59-879A-01640EB73822}"/>
                </a:ext>
              </a:extLst>
            </p:cNvPr>
            <p:cNvSpPr txBox="1"/>
            <p:nvPr/>
          </p:nvSpPr>
          <p:spPr>
            <a:xfrm>
              <a:off x="3909866" y="6400800"/>
              <a:ext cx="1362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/>
                <a:t>hVAT</a:t>
              </a:r>
              <a:r>
                <a:rPr lang="en-US" sz="1200" b="1" dirty="0"/>
                <a:t> primary cells</a:t>
              </a:r>
            </a:p>
          </p:txBody>
        </p:sp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DCD8D5E6-02F5-4CE0-9998-8599954ADC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12" t="44113" r="15188" b="-1"/>
            <a:stretch/>
          </p:blipFill>
          <p:spPr>
            <a:xfrm>
              <a:off x="5152181" y="4947381"/>
              <a:ext cx="972075" cy="1371600"/>
            </a:xfrm>
            <a:prstGeom prst="rect">
              <a:avLst/>
            </a:prstGeom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99CDEB8-04CB-4E50-BE65-099DECD556E3}"/>
                </a:ext>
              </a:extLst>
            </p:cNvPr>
            <p:cNvSpPr txBox="1"/>
            <p:nvPr/>
          </p:nvSpPr>
          <p:spPr>
            <a:xfrm>
              <a:off x="3344922" y="4731390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B9DED8B4-6816-4584-9090-A5AAB12BC75B}"/>
                </a:ext>
              </a:extLst>
            </p:cNvPr>
            <p:cNvSpPr txBox="1"/>
            <p:nvPr/>
          </p:nvSpPr>
          <p:spPr>
            <a:xfrm>
              <a:off x="4408913" y="4731390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4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AEEA7DA-1EEE-48F0-9C15-5F6CAAF4A9F6}"/>
                </a:ext>
              </a:extLst>
            </p:cNvPr>
            <p:cNvSpPr txBox="1"/>
            <p:nvPr/>
          </p:nvSpPr>
          <p:spPr>
            <a:xfrm>
              <a:off x="5475713" y="4731390"/>
              <a:ext cx="391687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D10</a:t>
              </a:r>
            </a:p>
          </p:txBody>
        </p:sp>
      </p:grpSp>
      <p:sp>
        <p:nvSpPr>
          <p:cNvPr id="63" name="Rectangle 62">
            <a:extLst>
              <a:ext uri="{FF2B5EF4-FFF2-40B4-BE49-F238E27FC236}">
                <a16:creationId xmlns:a16="http://schemas.microsoft.com/office/drawing/2014/main" id="{DA40912E-0551-4F40-BF5C-0D81CE71FE30}"/>
              </a:ext>
            </a:extLst>
          </p:cNvPr>
          <p:cNvSpPr/>
          <p:nvPr/>
        </p:nvSpPr>
        <p:spPr>
          <a:xfrm>
            <a:off x="405315" y="5433836"/>
            <a:ext cx="806314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endParaRPr lang="en-US" sz="1200" b="1" i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ative images for Oil Red O staining illustrating differentiation of 3T3-L1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adipocyt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. </a:t>
            </a:r>
          </a:p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for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ipoRed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illustrating differentiat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visceral (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VAT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ubcutaneous (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AT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eadipocytes.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86C159A-4306-478D-B339-6469AE845175}"/>
              </a:ext>
            </a:extLst>
          </p:cNvPr>
          <p:cNvSpPr txBox="1"/>
          <p:nvPr/>
        </p:nvSpPr>
        <p:spPr>
          <a:xfrm>
            <a:off x="258468" y="15434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30C5F72-8728-4FE2-8D79-B2C69823D441}"/>
              </a:ext>
            </a:extLst>
          </p:cNvPr>
          <p:cNvSpPr txBox="1"/>
          <p:nvPr/>
        </p:nvSpPr>
        <p:spPr>
          <a:xfrm>
            <a:off x="278761" y="243353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0F5A3A0-61E3-46DF-9E87-E77EBD0F8B2B}"/>
              </a:ext>
            </a:extLst>
          </p:cNvPr>
          <p:cNvSpPr txBox="1"/>
          <p:nvPr/>
        </p:nvSpPr>
        <p:spPr>
          <a:xfrm>
            <a:off x="5075254" y="233634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27074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51</TotalTime>
  <Words>232</Words>
  <Application>Microsoft Office PowerPoint</Application>
  <PresentationFormat>On-screen Show (4:3)</PresentationFormat>
  <Paragraphs>33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Yu Mincho</vt:lpstr>
      <vt:lpstr>Arial</vt:lpstr>
      <vt:lpstr>Calibri</vt:lpstr>
      <vt:lpstr>Times New Roman</vt:lpstr>
      <vt:lpstr>Office Theme</vt:lpstr>
      <vt:lpstr>Document</vt:lpstr>
      <vt:lpstr>Prism 8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bdelkrim.khadir</dc:creator>
  <cp:lastModifiedBy>Dr. Ali Tiss</cp:lastModifiedBy>
  <cp:revision>103</cp:revision>
  <cp:lastPrinted>2020-02-20T06:43:11Z</cp:lastPrinted>
  <dcterms:created xsi:type="dcterms:W3CDTF">2014-12-23T07:14:11Z</dcterms:created>
  <dcterms:modified xsi:type="dcterms:W3CDTF">2020-02-26T10:55:11Z</dcterms:modified>
</cp:coreProperties>
</file>